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7" r:id="rId2"/>
  </p:sldIdLst>
  <p:sldSz cx="6119813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01">
          <p15:clr>
            <a:srgbClr val="A4A3A4"/>
          </p15:clr>
        </p15:guide>
        <p15:guide id="2" pos="19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69" autoAdjust="0"/>
    <p:restoredTop sz="99466" autoAdjust="0"/>
  </p:normalViewPr>
  <p:slideViewPr>
    <p:cSldViewPr snapToGrid="0">
      <p:cViewPr varScale="1">
        <p:scale>
          <a:sx n="56" d="100"/>
          <a:sy n="56" d="100"/>
        </p:scale>
        <p:origin x="1464" y="66"/>
      </p:cViewPr>
      <p:guideLst>
        <p:guide orient="horz" pos="1701"/>
        <p:guide pos="19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4DC17F-EDE3-4E9C-AA0A-63A8269D432F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681163" y="1143000"/>
            <a:ext cx="34956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0401AD-8B71-450A-AAEC-2BBA5C145E0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911921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18360" rtl="0" eaLnBrk="1" latinLnBrk="0" hangingPunct="1">
      <a:defRPr sz="681" kern="1200">
        <a:solidFill>
          <a:schemeClr val="tx1"/>
        </a:solidFill>
        <a:latin typeface="+mn-lt"/>
        <a:ea typeface="+mn-ea"/>
        <a:cs typeface="+mn-cs"/>
      </a:defRPr>
    </a:lvl1pPr>
    <a:lvl2pPr marL="259180" algn="l" defTabSz="518360" rtl="0" eaLnBrk="1" latinLnBrk="0" hangingPunct="1">
      <a:defRPr sz="681" kern="1200">
        <a:solidFill>
          <a:schemeClr val="tx1"/>
        </a:solidFill>
        <a:latin typeface="+mn-lt"/>
        <a:ea typeface="+mn-ea"/>
        <a:cs typeface="+mn-cs"/>
      </a:defRPr>
    </a:lvl2pPr>
    <a:lvl3pPr marL="518360" algn="l" defTabSz="518360" rtl="0" eaLnBrk="1" latinLnBrk="0" hangingPunct="1">
      <a:defRPr sz="681" kern="1200">
        <a:solidFill>
          <a:schemeClr val="tx1"/>
        </a:solidFill>
        <a:latin typeface="+mn-lt"/>
        <a:ea typeface="+mn-ea"/>
        <a:cs typeface="+mn-cs"/>
      </a:defRPr>
    </a:lvl3pPr>
    <a:lvl4pPr marL="777541" algn="l" defTabSz="518360" rtl="0" eaLnBrk="1" latinLnBrk="0" hangingPunct="1">
      <a:defRPr sz="681" kern="1200">
        <a:solidFill>
          <a:schemeClr val="tx1"/>
        </a:solidFill>
        <a:latin typeface="+mn-lt"/>
        <a:ea typeface="+mn-ea"/>
        <a:cs typeface="+mn-cs"/>
      </a:defRPr>
    </a:lvl4pPr>
    <a:lvl5pPr marL="1036721" algn="l" defTabSz="518360" rtl="0" eaLnBrk="1" latinLnBrk="0" hangingPunct="1">
      <a:defRPr sz="681" kern="1200">
        <a:solidFill>
          <a:schemeClr val="tx1"/>
        </a:solidFill>
        <a:latin typeface="+mn-lt"/>
        <a:ea typeface="+mn-ea"/>
        <a:cs typeface="+mn-cs"/>
      </a:defRPr>
    </a:lvl5pPr>
    <a:lvl6pPr marL="1295901" algn="l" defTabSz="518360" rtl="0" eaLnBrk="1" latinLnBrk="0" hangingPunct="1">
      <a:defRPr sz="681" kern="1200">
        <a:solidFill>
          <a:schemeClr val="tx1"/>
        </a:solidFill>
        <a:latin typeface="+mn-lt"/>
        <a:ea typeface="+mn-ea"/>
        <a:cs typeface="+mn-cs"/>
      </a:defRPr>
    </a:lvl6pPr>
    <a:lvl7pPr marL="1555081" algn="l" defTabSz="518360" rtl="0" eaLnBrk="1" latinLnBrk="0" hangingPunct="1">
      <a:defRPr sz="681" kern="1200">
        <a:solidFill>
          <a:schemeClr val="tx1"/>
        </a:solidFill>
        <a:latin typeface="+mn-lt"/>
        <a:ea typeface="+mn-ea"/>
        <a:cs typeface="+mn-cs"/>
      </a:defRPr>
    </a:lvl7pPr>
    <a:lvl8pPr marL="1814262" algn="l" defTabSz="518360" rtl="0" eaLnBrk="1" latinLnBrk="0" hangingPunct="1">
      <a:defRPr sz="681" kern="1200">
        <a:solidFill>
          <a:schemeClr val="tx1"/>
        </a:solidFill>
        <a:latin typeface="+mn-lt"/>
        <a:ea typeface="+mn-ea"/>
        <a:cs typeface="+mn-cs"/>
      </a:defRPr>
    </a:lvl8pPr>
    <a:lvl9pPr marL="2073442" algn="l" defTabSz="518360" rtl="0" eaLnBrk="1" latinLnBrk="0" hangingPunct="1">
      <a:defRPr sz="68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>
          <a:xfrm>
            <a:off x="1681163" y="1143000"/>
            <a:ext cx="3495675" cy="3086100"/>
          </a:xfrm>
        </p:spPr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A7B12B-8154-4F9E-8632-EB70D5F1E112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629047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7" y="883861"/>
            <a:ext cx="5201841" cy="1880235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2836606"/>
            <a:ext cx="4589860" cy="1303912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F5B8B-1FD7-4C47-BC24-B5BCED2A13C9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B0956-DFFF-47E5-8D7F-ADB7AB21AF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489698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F5B8B-1FD7-4C47-BC24-B5BCED2A13C9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B0956-DFFF-47E5-8D7F-ADB7AB21AF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87802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2" y="287537"/>
            <a:ext cx="1319585" cy="457682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287537"/>
            <a:ext cx="3882256" cy="457682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F5B8B-1FD7-4C47-BC24-B5BCED2A13C9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B0956-DFFF-47E5-8D7F-ADB7AB21AF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50504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F5B8B-1FD7-4C47-BC24-B5BCED2A13C9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B0956-DFFF-47E5-8D7F-ADB7AB21AF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22298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1" y="1346420"/>
            <a:ext cx="5278339" cy="2246531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1" y="3614203"/>
            <a:ext cx="5278339" cy="1181398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F5B8B-1FD7-4C47-BC24-B5BCED2A13C9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B0956-DFFF-47E5-8D7F-ADB7AB21AF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234660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8" y="1437680"/>
            <a:ext cx="2600921" cy="34266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6" y="1437680"/>
            <a:ext cx="2600921" cy="34266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F5B8B-1FD7-4C47-BC24-B5BCED2A13C9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B0956-DFFF-47E5-8D7F-ADB7AB21AF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53708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5" y="287537"/>
            <a:ext cx="5278339" cy="104388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6" y="1323916"/>
            <a:ext cx="2588967" cy="648831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6" y="1972747"/>
            <a:ext cx="2588967" cy="29016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323916"/>
            <a:ext cx="2601718" cy="648831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1972747"/>
            <a:ext cx="2601718" cy="29016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F5B8B-1FD7-4C47-BC24-B5BCED2A13C9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B0956-DFFF-47E5-8D7F-ADB7AB21AF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76936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F5B8B-1FD7-4C47-BC24-B5BCED2A13C9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B0956-DFFF-47E5-8D7F-ADB7AB21AF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441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F5B8B-1FD7-4C47-BC24-B5BCED2A13C9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B0956-DFFF-47E5-8D7F-ADB7AB21AF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27374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5" y="360045"/>
            <a:ext cx="1973799" cy="1260157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9" y="777598"/>
            <a:ext cx="3098155" cy="3837980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5" y="1620202"/>
            <a:ext cx="1973799" cy="300162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F5B8B-1FD7-4C47-BC24-B5BCED2A13C9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B0956-DFFF-47E5-8D7F-ADB7AB21AF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21988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5" y="360045"/>
            <a:ext cx="1973799" cy="1260157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9" y="777598"/>
            <a:ext cx="3098155" cy="3837980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5" y="1620202"/>
            <a:ext cx="1973799" cy="300162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F5B8B-1FD7-4C47-BC24-B5BCED2A13C9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B0956-DFFF-47E5-8D7F-ADB7AB21AF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09506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8" y="287537"/>
            <a:ext cx="5278339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8" y="1437680"/>
            <a:ext cx="5278339" cy="342667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5005626"/>
            <a:ext cx="1376958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5F5B8B-1FD7-4C47-BC24-B5BCED2A13C9}" type="datetimeFigureOut">
              <a:rPr lang="sv-SE" smtClean="0"/>
              <a:t>2021-08-2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9" y="5005626"/>
            <a:ext cx="2065437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5005626"/>
            <a:ext cx="1376958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9B0956-DFFF-47E5-8D7F-ADB7AB21AF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72462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13 CuadroTexto"/>
          <p:cNvSpPr txBox="1"/>
          <p:nvPr/>
        </p:nvSpPr>
        <p:spPr>
          <a:xfrm>
            <a:off x="442167" y="161741"/>
            <a:ext cx="16908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>
              <a:defRPr sz="1400" b="1"/>
            </a:lvl1pPr>
          </a:lstStyle>
          <a:p>
            <a:r>
              <a:rPr lang="es-ES" sz="900" dirty="0" err="1"/>
              <a:t>Supplementary</a:t>
            </a:r>
            <a:r>
              <a:rPr lang="es-ES" sz="900" dirty="0"/>
              <a:t> </a:t>
            </a:r>
            <a:r>
              <a:rPr lang="es-ES" sz="900" dirty="0" err="1"/>
              <a:t>fig</a:t>
            </a:r>
            <a:r>
              <a:rPr lang="es-ES" sz="900" dirty="0"/>
              <a:t> 1</a:t>
            </a:r>
          </a:p>
        </p:txBody>
      </p:sp>
      <p:sp>
        <p:nvSpPr>
          <p:cNvPr id="15" name="textruta 14">
            <a:extLst>
              <a:ext uri="{FF2B5EF4-FFF2-40B4-BE49-F238E27FC236}">
                <a16:creationId xmlns:a16="http://schemas.microsoft.com/office/drawing/2014/main" id="{679A1D5A-A02D-4B6B-8E63-B617F68C6610}"/>
              </a:ext>
            </a:extLst>
          </p:cNvPr>
          <p:cNvSpPr txBox="1"/>
          <p:nvPr/>
        </p:nvSpPr>
        <p:spPr>
          <a:xfrm>
            <a:off x="3224616" y="649677"/>
            <a:ext cx="1431107" cy="1877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620" dirty="0" err="1"/>
              <a:t>regulatory</a:t>
            </a:r>
            <a:r>
              <a:rPr lang="es-ES" sz="620" dirty="0"/>
              <a:t> T </a:t>
            </a:r>
            <a:r>
              <a:rPr lang="es-ES" sz="620" dirty="0" err="1"/>
              <a:t>cells</a:t>
            </a:r>
            <a:r>
              <a:rPr lang="es-ES" sz="620" dirty="0"/>
              <a:t> </a:t>
            </a:r>
            <a:r>
              <a:rPr lang="es-ES" sz="620" dirty="0" err="1"/>
              <a:t>within</a:t>
            </a:r>
            <a:r>
              <a:rPr lang="es-ES" sz="620" dirty="0"/>
              <a:t> CD4+ T </a:t>
            </a:r>
            <a:r>
              <a:rPr lang="es-ES" sz="620" dirty="0" err="1"/>
              <a:t>cells</a:t>
            </a:r>
            <a:endParaRPr lang="es-ES" sz="620" dirty="0"/>
          </a:p>
        </p:txBody>
      </p:sp>
      <p:sp>
        <p:nvSpPr>
          <p:cNvPr id="17" name="textruta 16">
            <a:extLst>
              <a:ext uri="{FF2B5EF4-FFF2-40B4-BE49-F238E27FC236}">
                <a16:creationId xmlns:a16="http://schemas.microsoft.com/office/drawing/2014/main" id="{E6DEC328-8537-48AC-A36C-7362B13DE1BF}"/>
              </a:ext>
            </a:extLst>
          </p:cNvPr>
          <p:cNvSpPr txBox="1"/>
          <p:nvPr/>
        </p:nvSpPr>
        <p:spPr>
          <a:xfrm>
            <a:off x="4566709" y="666120"/>
            <a:ext cx="1264549" cy="2831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620" dirty="0">
                <a:cs typeface="Arial" panose="020B0604020202020204" pitchFamily="34" charset="0"/>
              </a:rPr>
              <a:t>non-</a:t>
            </a:r>
            <a:r>
              <a:rPr lang="es-ES" sz="620" dirty="0" err="1">
                <a:cs typeface="Arial" panose="020B0604020202020204" pitchFamily="34" charset="0"/>
              </a:rPr>
              <a:t>suppresive</a:t>
            </a:r>
            <a:r>
              <a:rPr lang="es-ES" sz="620" dirty="0">
                <a:cs typeface="Arial" panose="020B0604020202020204" pitchFamily="34" charset="0"/>
              </a:rPr>
              <a:t>, </a:t>
            </a:r>
            <a:r>
              <a:rPr lang="es-ES" sz="620" dirty="0" err="1">
                <a:cs typeface="Arial" panose="020B0604020202020204" pitchFamily="34" charset="0"/>
              </a:rPr>
              <a:t>resting</a:t>
            </a:r>
            <a:r>
              <a:rPr lang="es-ES" sz="620" dirty="0">
                <a:cs typeface="Arial" panose="020B0604020202020204" pitchFamily="34" charset="0"/>
              </a:rPr>
              <a:t> and </a:t>
            </a:r>
            <a:r>
              <a:rPr lang="es-ES" sz="620" dirty="0" err="1">
                <a:cs typeface="Arial" panose="020B0604020202020204" pitchFamily="34" charset="0"/>
              </a:rPr>
              <a:t>activated</a:t>
            </a:r>
            <a:r>
              <a:rPr lang="es-ES" sz="620" dirty="0">
                <a:cs typeface="Arial" panose="020B0604020202020204" pitchFamily="34" charset="0"/>
              </a:rPr>
              <a:t> </a:t>
            </a:r>
            <a:r>
              <a:rPr lang="es-ES" sz="620" dirty="0" err="1">
                <a:cs typeface="Arial" panose="020B0604020202020204" pitchFamily="34" charset="0"/>
              </a:rPr>
              <a:t>regulatory</a:t>
            </a:r>
            <a:r>
              <a:rPr lang="es-ES" sz="620" dirty="0">
                <a:cs typeface="Arial" panose="020B0604020202020204" pitchFamily="34" charset="0"/>
              </a:rPr>
              <a:t> T </a:t>
            </a:r>
            <a:r>
              <a:rPr lang="es-ES" sz="620" dirty="0" err="1">
                <a:cs typeface="Arial" panose="020B0604020202020204" pitchFamily="34" charset="0"/>
              </a:rPr>
              <a:t>cells</a:t>
            </a:r>
            <a:endParaRPr lang="es-ES" sz="620" dirty="0"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EE74803-2893-473F-8CF3-70D8C4E4DF82}"/>
              </a:ext>
            </a:extLst>
          </p:cNvPr>
          <p:cNvSpPr txBox="1"/>
          <p:nvPr/>
        </p:nvSpPr>
        <p:spPr>
          <a:xfrm>
            <a:off x="24004" y="336267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DB30FD2-5139-4403-8873-CB445D33523D}"/>
              </a:ext>
            </a:extLst>
          </p:cNvPr>
          <p:cNvSpPr txBox="1"/>
          <p:nvPr/>
        </p:nvSpPr>
        <p:spPr>
          <a:xfrm>
            <a:off x="3057593" y="478802"/>
            <a:ext cx="4723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ruta 14">
            <a:extLst>
              <a:ext uri="{FF2B5EF4-FFF2-40B4-BE49-F238E27FC236}">
                <a16:creationId xmlns:a16="http://schemas.microsoft.com/office/drawing/2014/main" id="{A0D9FEA3-DDA7-4953-9287-2A8C61A38C10}"/>
              </a:ext>
            </a:extLst>
          </p:cNvPr>
          <p:cNvSpPr txBox="1"/>
          <p:nvPr/>
        </p:nvSpPr>
        <p:spPr>
          <a:xfrm>
            <a:off x="3412328" y="2435142"/>
            <a:ext cx="1431107" cy="1877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620" dirty="0"/>
              <a:t>CD4+ and CD8+ T </a:t>
            </a:r>
            <a:r>
              <a:rPr lang="es-ES" sz="620" dirty="0" err="1"/>
              <a:t>cells</a:t>
            </a:r>
            <a:endParaRPr lang="es-ES" sz="62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760BDE7-11F5-4C12-98C5-588E70AE8BA2}"/>
              </a:ext>
            </a:extLst>
          </p:cNvPr>
          <p:cNvSpPr txBox="1"/>
          <p:nvPr/>
        </p:nvSpPr>
        <p:spPr>
          <a:xfrm>
            <a:off x="3083903" y="2373245"/>
            <a:ext cx="4723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C42EB67-F823-496D-A43F-802F5A77A2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3082" y="515606"/>
            <a:ext cx="1409900" cy="85447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D88DAA2-F1C7-4437-83A7-46676334629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66664" y="404037"/>
            <a:ext cx="1400299" cy="944998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C138567-EFF6-4C92-80F7-7B74E26DEBE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9330" y="1347644"/>
            <a:ext cx="1404414" cy="886022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83DC50B9-EA6B-4C2A-B968-33FCA901ABF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07833" y="1332349"/>
            <a:ext cx="1407157" cy="886022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58102899-25B9-46F6-BD66-62F5F493B4E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9999" y="2248479"/>
            <a:ext cx="1385213" cy="886022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48E17137-2614-43CF-B820-10B4E6312ED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29423" y="2254856"/>
            <a:ext cx="1398928" cy="891509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1E913407-92E1-480F-AFCA-481DE3EC625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89618" y="3198865"/>
            <a:ext cx="1382470" cy="884651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E3BFBB38-D545-481B-ACD2-88EE9E32F36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306568" y="983093"/>
            <a:ext cx="1124628" cy="1233024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DA09DBFD-D9F9-478D-BED9-72E8355BC19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355712" y="1020226"/>
            <a:ext cx="1279607" cy="1051979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5E4FECCA-F441-4E00-BDC8-2358CD5085F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428323" y="2673132"/>
            <a:ext cx="1161659" cy="1043750"/>
          </a:xfrm>
          <a:prstGeom prst="rect">
            <a:avLst/>
          </a:prstGeom>
        </p:spPr>
      </p:pic>
      <p:sp>
        <p:nvSpPr>
          <p:cNvPr id="4" name="3 Rectángulo"/>
          <p:cNvSpPr/>
          <p:nvPr/>
        </p:nvSpPr>
        <p:spPr>
          <a:xfrm>
            <a:off x="24004" y="4178994"/>
            <a:ext cx="5958354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defTabSz="914400">
              <a:defRPr/>
            </a:pPr>
            <a:r>
              <a:rPr lang="es-ES" sz="800" b="1" dirty="0" err="1">
                <a:latin typeface="Arial" pitchFamily="34" charset="0"/>
                <a:cs typeface="Arial" pitchFamily="34" charset="0"/>
              </a:rPr>
              <a:t>Supplementary</a:t>
            </a:r>
            <a:r>
              <a:rPr lang="es-ES" sz="800" b="1" dirty="0">
                <a:latin typeface="Arial" pitchFamily="34" charset="0"/>
                <a:cs typeface="Arial" pitchFamily="34" charset="0"/>
              </a:rPr>
              <a:t> figure 1:</a:t>
            </a:r>
            <a:r>
              <a:rPr lang="es-ES" sz="800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800" b="1" dirty="0">
                <a:latin typeface="Arial" pitchFamily="34" charset="0"/>
                <a:cs typeface="Arial" pitchFamily="34" charset="0"/>
              </a:rPr>
              <a:t>A</a:t>
            </a:r>
            <a:r>
              <a:rPr lang="en-US" sz="800" b="1" dirty="0">
                <a:latin typeface="Arial" pitchFamily="34" charset="0"/>
                <a:cs typeface="Arial" pitchFamily="34" charset="0"/>
              </a:rPr>
              <a:t>) 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Cytokine secretion (</a:t>
            </a:r>
            <a:r>
              <a:rPr lang="en-US" sz="800" dirty="0" err="1">
                <a:latin typeface="Arial" pitchFamily="34" charset="0"/>
                <a:cs typeface="Arial" pitchFamily="34" charset="0"/>
              </a:rPr>
              <a:t>pg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/ml) detected by </a:t>
            </a:r>
            <a:r>
              <a:rPr lang="en-US" sz="800" dirty="0" err="1">
                <a:latin typeface="Arial" pitchFamily="34" charset="0"/>
                <a:cs typeface="Arial" pitchFamily="34" charset="0"/>
              </a:rPr>
              <a:t>Luminex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 in PBMCs supernatants after 7 days culture in the presence of GAD</a:t>
            </a:r>
            <a:r>
              <a:rPr lang="en-US" sz="800" baseline="-25000" dirty="0">
                <a:latin typeface="Arial" pitchFamily="34" charset="0"/>
                <a:cs typeface="Arial" pitchFamily="34" charset="0"/>
              </a:rPr>
              <a:t>65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 (5 µg/ml). Horizontal lines represent the median. Differences between time-points within the same group were calculated using Wilcoxon paired test. </a:t>
            </a:r>
            <a:endParaRPr lang="es-ES" sz="800" dirty="0">
              <a:latin typeface="Arial" pitchFamily="34" charset="0"/>
              <a:cs typeface="Arial" pitchFamily="34" charset="0"/>
            </a:endParaRPr>
          </a:p>
          <a:p>
            <a:pPr lvl="0" algn="just" defTabSz="914400">
              <a:defRPr/>
            </a:pPr>
            <a:r>
              <a:rPr lang="en-US" sz="8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800" b="1" dirty="0">
                <a:latin typeface="Arial" pitchFamily="34" charset="0"/>
                <a:cs typeface="Arial" pitchFamily="34" charset="0"/>
              </a:rPr>
              <a:t>B)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 Median percentage of regulatory T cells within CD4</a:t>
            </a:r>
            <a:r>
              <a:rPr lang="en-US" sz="8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 T cells and non-suppressive (</a:t>
            </a:r>
            <a:r>
              <a:rPr lang="en-US" sz="800" dirty="0" err="1">
                <a:latin typeface="Arial" pitchFamily="34" charset="0"/>
                <a:cs typeface="Arial" pitchFamily="34" charset="0"/>
              </a:rPr>
              <a:t>nsTreg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, CD45RA</a:t>
            </a:r>
            <a:r>
              <a:rPr lang="en-US" sz="800" baseline="30000" dirty="0">
                <a:latin typeface="Arial" pitchFamily="34" charset="0"/>
                <a:cs typeface="Arial" pitchFamily="34" charset="0"/>
              </a:rPr>
              <a:t>-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FOXP3</a:t>
            </a:r>
            <a:r>
              <a:rPr lang="en-US" sz="800" baseline="30000" dirty="0">
                <a:latin typeface="Arial" pitchFamily="34" charset="0"/>
                <a:cs typeface="Arial" pitchFamily="34" charset="0"/>
              </a:rPr>
              <a:t>low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, white triangles), resting (</a:t>
            </a:r>
            <a:r>
              <a:rPr lang="en-US" sz="800" dirty="0" err="1">
                <a:latin typeface="Arial" pitchFamily="34" charset="0"/>
                <a:cs typeface="Arial" pitchFamily="34" charset="0"/>
              </a:rPr>
              <a:t>rTreg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, CD45RA</a:t>
            </a:r>
            <a:r>
              <a:rPr lang="en-US" sz="8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FOXP3</a:t>
            </a:r>
            <a:r>
              <a:rPr lang="en-US" sz="800" baseline="30000" dirty="0">
                <a:latin typeface="Arial" pitchFamily="34" charset="0"/>
                <a:cs typeface="Arial" pitchFamily="34" charset="0"/>
              </a:rPr>
              <a:t>low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, circles), and activated (</a:t>
            </a:r>
            <a:r>
              <a:rPr lang="en-US" sz="800" dirty="0" err="1">
                <a:latin typeface="Arial" pitchFamily="34" charset="0"/>
                <a:cs typeface="Arial" pitchFamily="34" charset="0"/>
              </a:rPr>
              <a:t>aTreg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, CD45RA</a:t>
            </a:r>
            <a:r>
              <a:rPr lang="en-US" sz="800" baseline="30000" dirty="0">
                <a:latin typeface="Arial" pitchFamily="34" charset="0"/>
                <a:cs typeface="Arial" pitchFamily="34" charset="0"/>
              </a:rPr>
              <a:t>-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FOXP3</a:t>
            </a:r>
            <a:r>
              <a:rPr lang="en-US" sz="800" baseline="30000" dirty="0">
                <a:latin typeface="Arial" pitchFamily="34" charset="0"/>
                <a:cs typeface="Arial" pitchFamily="34" charset="0"/>
              </a:rPr>
              <a:t>high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, black triangles) regulatory T cells in patients receiving GAD-alum injections into the lymph-node. Bars indicate interquartile range. Differences within the same group were calculated using Wilcoxon paired test. </a:t>
            </a:r>
          </a:p>
          <a:p>
            <a:pPr lvl="0" algn="just" defTabSz="914400">
              <a:defRPr/>
            </a:pPr>
            <a:r>
              <a:rPr lang="en-US" sz="800" b="1" dirty="0">
                <a:latin typeface="Arial" pitchFamily="34" charset="0"/>
                <a:cs typeface="Arial" pitchFamily="34" charset="0"/>
              </a:rPr>
              <a:t>C) 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Median percentage of activated CD4</a:t>
            </a:r>
            <a:r>
              <a:rPr lang="en-US" sz="8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 (triangles) and CD8</a:t>
            </a:r>
            <a:r>
              <a:rPr lang="en-US" sz="8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 (circles) T cells after stimulation with GAD</a:t>
            </a:r>
            <a:r>
              <a:rPr lang="en-US" sz="800" baseline="-25000" dirty="0">
                <a:latin typeface="Arial" pitchFamily="34" charset="0"/>
                <a:cs typeface="Arial" pitchFamily="34" charset="0"/>
              </a:rPr>
              <a:t>65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 (5 µg/ml).</a:t>
            </a:r>
          </a:p>
        </p:txBody>
      </p:sp>
    </p:spTree>
    <p:extLst>
      <p:ext uri="{BB962C8B-B14F-4D97-AF65-F5344CB8AC3E}">
        <p14:creationId xmlns:p14="http://schemas.microsoft.com/office/powerpoint/2010/main" val="3097036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</TotalTime>
  <Words>186</Words>
  <Application>Microsoft Office PowerPoint</Application>
  <PresentationFormat>Anpassad</PresentationFormat>
  <Paragraphs>11</Paragraphs>
  <Slides>1</Slides>
  <Notes>1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 Puente Marin</dc:creator>
  <cp:lastModifiedBy>Johnny Ludvigsson</cp:lastModifiedBy>
  <cp:revision>12</cp:revision>
  <dcterms:created xsi:type="dcterms:W3CDTF">2021-04-09T12:14:57Z</dcterms:created>
  <dcterms:modified xsi:type="dcterms:W3CDTF">2021-08-23T09:40:19Z</dcterms:modified>
</cp:coreProperties>
</file>